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456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374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56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540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1906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9826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66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999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33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186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493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80282-4A4A-4FFB-822F-A6027996485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ECBC3-8A25-4488-BDA6-EFEBBDCD2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781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Lab1\Desktop\pdl p21 p2.tif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31088" y="3266760"/>
            <a:ext cx="5760000" cy="1440000"/>
          </a:xfrm>
          <a:prstGeom prst="rect">
            <a:avLst/>
          </a:prstGeom>
          <a:noFill/>
        </p:spPr>
      </p:pic>
      <p:pic>
        <p:nvPicPr>
          <p:cNvPr id="6" name="Picture 4" descr="C:\Users\Lab1\Desktop\pdl p16 p15.ti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31088" y="1782008"/>
            <a:ext cx="5760000" cy="1440000"/>
          </a:xfrm>
          <a:prstGeom prst="rect">
            <a:avLst/>
          </a:prstGeom>
          <a:noFill/>
        </p:spPr>
      </p:pic>
      <p:sp>
        <p:nvSpPr>
          <p:cNvPr id="7" name="CasellaDiTesto 6"/>
          <p:cNvSpPr txBox="1"/>
          <p:nvPr/>
        </p:nvSpPr>
        <p:spPr>
          <a:xfrm>
            <a:off x="1999040" y="910867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Connettore 1 7"/>
          <p:cNvCxnSpPr/>
          <p:nvPr/>
        </p:nvCxnSpPr>
        <p:spPr>
          <a:xfrm>
            <a:off x="1999040" y="539752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asellaDiTesto 8"/>
          <p:cNvSpPr txBox="1"/>
          <p:nvPr/>
        </p:nvSpPr>
        <p:spPr>
          <a:xfrm>
            <a:off x="1999040" y="2351027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1494985" y="161991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16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1991544" y="393520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Connettore 1 11"/>
          <p:cNvCxnSpPr/>
          <p:nvPr/>
        </p:nvCxnSpPr>
        <p:spPr>
          <a:xfrm>
            <a:off x="1991544" y="3564088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/>
          <p:cNvSpPr txBox="1"/>
          <p:nvPr/>
        </p:nvSpPr>
        <p:spPr>
          <a:xfrm>
            <a:off x="1487488" y="464425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21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Picture 5" descr="C:\Users\Lab1\Desktop\05.ti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431088" y="323464"/>
            <a:ext cx="5760000" cy="1440000"/>
          </a:xfrm>
          <a:prstGeom prst="rect">
            <a:avLst/>
          </a:prstGeom>
          <a:noFill/>
        </p:spPr>
      </p:pic>
      <p:sp>
        <p:nvSpPr>
          <p:cNvPr id="15" name="CasellaDiTesto 14"/>
          <p:cNvSpPr txBox="1"/>
          <p:nvPr/>
        </p:nvSpPr>
        <p:spPr>
          <a:xfrm>
            <a:off x="1991544" y="537536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" name="Gruppo 33"/>
          <p:cNvGrpSpPr/>
          <p:nvPr/>
        </p:nvGrpSpPr>
        <p:grpSpPr>
          <a:xfrm>
            <a:off x="2431088" y="4725304"/>
            <a:ext cx="5760640" cy="1440000"/>
            <a:chOff x="907088" y="4725304"/>
            <a:chExt cx="5760640" cy="1440000"/>
          </a:xfrm>
        </p:grpSpPr>
        <p:pic>
          <p:nvPicPr>
            <p:cNvPr id="5" name="Picture 8" descr="C:\Users\Lab1\Desktop\pdl p21 p15 (2).tif"/>
            <p:cNvPicPr preferRelativeResize="0"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907088" y="4725304"/>
              <a:ext cx="5760000" cy="1440000"/>
            </a:xfrm>
            <a:prstGeom prst="rect">
              <a:avLst/>
            </a:prstGeom>
            <a:noFill/>
          </p:spPr>
        </p:pic>
        <p:sp>
          <p:nvSpPr>
            <p:cNvPr id="16" name="CasellaDiTesto 15"/>
            <p:cNvSpPr txBox="1"/>
            <p:nvPr/>
          </p:nvSpPr>
          <p:spPr>
            <a:xfrm>
              <a:off x="6341998" y="590989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__</a:t>
              </a:r>
              <a:endParaRPr lang="it-IT" sz="10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CasellaDiTesto 16"/>
          <p:cNvSpPr txBox="1"/>
          <p:nvPr/>
        </p:nvSpPr>
        <p:spPr>
          <a:xfrm>
            <a:off x="2431088" y="323464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3871248" y="323464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5311408" y="323464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6751568" y="323464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2431088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871248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5311408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6751568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2431088" y="3266760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871248" y="3266760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5311408" y="3266760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6751568" y="3266760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2431088" y="4725304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3871248" y="4725304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5311408" y="4725304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6751568" y="4725304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CasellaDiTesto 32"/>
          <p:cNvSpPr txBox="1"/>
          <p:nvPr/>
        </p:nvSpPr>
        <p:spPr>
          <a:xfrm>
            <a:off x="8184232" y="332657"/>
            <a:ext cx="2304256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Figure S1.  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sz="1200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PDL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2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2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PDL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15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2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208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o, Dina</dc:creator>
  <cp:lastModifiedBy>Jaro, Dina</cp:lastModifiedBy>
  <cp:revision>2</cp:revision>
  <dcterms:created xsi:type="dcterms:W3CDTF">2017-03-22T22:39:18Z</dcterms:created>
  <dcterms:modified xsi:type="dcterms:W3CDTF">2017-03-22T22:39:51Z</dcterms:modified>
</cp:coreProperties>
</file>